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1212" y="5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448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8423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1718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678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191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2635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467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7479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647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9402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579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732432-6BBF-4C62-B9D3-BAAA16CEB371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5FFF4D-CA6B-4892-A84D-CEBEAB692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733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雪, 水, 小さい, スキー が含まれている画像&#10;&#10;自動的に生成された説明">
            <a:extLst>
              <a:ext uri="{FF2B5EF4-FFF2-40B4-BE49-F238E27FC236}">
                <a16:creationId xmlns:a16="http://schemas.microsoft.com/office/drawing/2014/main" id="{404B8B68-B0D5-294D-DAC9-2EDA59CFE5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1946" y="1488005"/>
            <a:ext cx="2888755" cy="226569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79670E5-5151-24CE-CD03-A9DEE25880D5}"/>
              </a:ext>
            </a:extLst>
          </p:cNvPr>
          <p:cNvSpPr txBox="1"/>
          <p:nvPr/>
        </p:nvSpPr>
        <p:spPr>
          <a:xfrm>
            <a:off x="1531137" y="1197991"/>
            <a:ext cx="2431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Normal ovary</a:t>
            </a:r>
            <a:endParaRPr lang="ja-JP" altLang="en-US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85FAF7F2-32F9-EEA4-C002-7BBB6171BA18}"/>
              </a:ext>
            </a:extLst>
          </p:cNvPr>
          <p:cNvSpPr/>
          <p:nvPr/>
        </p:nvSpPr>
        <p:spPr>
          <a:xfrm rot="16200000">
            <a:off x="4087920" y="3333465"/>
            <a:ext cx="108000" cy="662400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/>
          </a:p>
        </p:txBody>
      </p:sp>
      <p:pic>
        <p:nvPicPr>
          <p:cNvPr id="7" name="図 6" descr="小さい, 食品, テーブル, 若い が含まれている画像&#10;&#10;自動的に生成された説明">
            <a:extLst>
              <a:ext uri="{FF2B5EF4-FFF2-40B4-BE49-F238E27FC236}">
                <a16:creationId xmlns:a16="http://schemas.microsoft.com/office/drawing/2014/main" id="{54FC5C4D-7E8F-96CE-DE88-3880B3BA4E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9929" y="1480147"/>
            <a:ext cx="2888756" cy="2265691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A06F9E5-9047-19A5-A2EB-DC152ADD2CB4}"/>
              </a:ext>
            </a:extLst>
          </p:cNvPr>
          <p:cNvSpPr/>
          <p:nvPr/>
        </p:nvSpPr>
        <p:spPr>
          <a:xfrm rot="16200000">
            <a:off x="7120201" y="3333466"/>
            <a:ext cx="108000" cy="662400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797EB44-B774-51B1-4785-87EEAD47FB1F}"/>
              </a:ext>
            </a:extLst>
          </p:cNvPr>
          <p:cNvSpPr txBox="1"/>
          <p:nvPr/>
        </p:nvSpPr>
        <p:spPr>
          <a:xfrm>
            <a:off x="4581511" y="1197991"/>
            <a:ext cx="24316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Normal adrenal gland</a:t>
            </a:r>
            <a:endParaRPr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9633AFA-4D71-0C5D-AF63-6620417A9E69}"/>
              </a:ext>
            </a:extLst>
          </p:cNvPr>
          <p:cNvSpPr txBox="1"/>
          <p:nvPr/>
        </p:nvSpPr>
        <p:spPr>
          <a:xfrm>
            <a:off x="1474444" y="4027994"/>
            <a:ext cx="703314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l figure 1</a:t>
            </a:r>
          </a:p>
          <a:p>
            <a:r>
              <a:rPr lang="en-US" altLang="ja-JP" dirty="0"/>
              <a:t>Normal ovarian granulosa and stromal cells, and adrenal gland cells</a:t>
            </a:r>
            <a:br>
              <a:rPr lang="en-US" altLang="ja-JP" dirty="0"/>
            </a:br>
            <a:r>
              <a:rPr lang="en-US" altLang="ja-JP" dirty="0"/>
              <a:t>showed weak positivity or negativity for MUC4.</a:t>
            </a:r>
          </a:p>
          <a:p>
            <a:r>
              <a:rPr lang="en-US" altLang="ja-JP" dirty="0"/>
              <a:t>Bar=100 </a:t>
            </a:r>
            <a:r>
              <a:rPr lang="en-US" altLang="ja-JP" dirty="0" err="1"/>
              <a:t>μm</a:t>
            </a:r>
            <a:r>
              <a:rPr lang="en-US" altLang="ja-JP" dirty="0"/>
              <a:t>.</a:t>
            </a:r>
          </a:p>
          <a:p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46350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33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千裕 井上</dc:creator>
  <cp:lastModifiedBy>千裕 井上</cp:lastModifiedBy>
  <cp:revision>9</cp:revision>
  <dcterms:created xsi:type="dcterms:W3CDTF">2025-01-14T10:04:37Z</dcterms:created>
  <dcterms:modified xsi:type="dcterms:W3CDTF">2025-01-24T01:26:31Z</dcterms:modified>
</cp:coreProperties>
</file>